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581" autoAdjust="0"/>
  </p:normalViewPr>
  <p:slideViewPr>
    <p:cSldViewPr snapToGrid="0" snapToObjects="1">
      <p:cViewPr>
        <p:scale>
          <a:sx n="100" d="100"/>
          <a:sy n="100" d="100"/>
        </p:scale>
        <p:origin x="-258" y="-2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230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659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04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884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514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409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282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68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710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404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606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B19FE-FA69-844D-9CD7-167D17E07571}" type="datetimeFigureOut">
              <a:rPr lang="en-US" smtClean="0"/>
              <a:t>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F6E9D-69CD-2249-9B6A-EC303BB4D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135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380830" y="166414"/>
            <a:ext cx="1488965" cy="560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IH-AARP Baseline cohort </a:t>
            </a:r>
          </a:p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566,398</a:t>
            </a:r>
            <a:endParaRPr lang="en-US" sz="1200" dirty="0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533667" y="1191170"/>
            <a:ext cx="1183291" cy="2872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550,638</a:t>
            </a:r>
            <a:endParaRPr lang="en-US" sz="1200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>
            <a:stCxn id="3" idx="2"/>
          </p:cNvCxnSpPr>
          <p:nvPr/>
        </p:nvCxnSpPr>
        <p:spPr>
          <a:xfrm>
            <a:off x="4125313" y="726965"/>
            <a:ext cx="0" cy="44668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416329" y="726965"/>
            <a:ext cx="1305035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roxy respondent</a:t>
            </a:r>
          </a:p>
          <a:p>
            <a:r>
              <a:rPr lang="en-US" sz="1000" dirty="0" smtClean="0"/>
              <a:t>N=15,760</a:t>
            </a:r>
            <a:endParaRPr lang="en-US" sz="1000" dirty="0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4120054" y="957531"/>
            <a:ext cx="1296275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3531037" y="1848069"/>
            <a:ext cx="1178034" cy="3024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501,320</a:t>
            </a:r>
            <a:endParaRPr lang="en-US" sz="1200" dirty="0">
              <a:solidFill>
                <a:schemeClr val="tx1"/>
              </a:solidFill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4120054" y="1478425"/>
            <a:ext cx="5256" cy="36964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416329" y="1323511"/>
            <a:ext cx="200572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Self reported cancer diagnosis at baseline (n=49,318)</a:t>
            </a:r>
          </a:p>
          <a:p>
            <a:r>
              <a:rPr lang="en-US" sz="800" dirty="0" smtClean="0"/>
              <a:t>Prostate=10,640; Breast=10,875; Colorectal=4584; Other cancers=23,219</a:t>
            </a:r>
            <a:endParaRPr lang="en-US" sz="800" dirty="0"/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4120054" y="1646677"/>
            <a:ext cx="1296275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3519871" y="2584452"/>
            <a:ext cx="1210877" cy="3058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499,304</a:t>
            </a:r>
            <a:endParaRPr lang="en-US" sz="1200" dirty="0">
              <a:solidFill>
                <a:schemeClr val="tx1"/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4111296" y="2150515"/>
            <a:ext cx="0" cy="41516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421586" y="2097116"/>
            <a:ext cx="1340069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ecord of any cancer before entry</a:t>
            </a:r>
          </a:p>
          <a:p>
            <a:r>
              <a:rPr lang="en-US" sz="800" dirty="0" smtClean="0"/>
              <a:t>N=2016</a:t>
            </a:r>
            <a:endParaRPr lang="en-US" sz="800" dirty="0"/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4113484" y="2358726"/>
            <a:ext cx="129627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3524467" y="3291979"/>
            <a:ext cx="1178034" cy="3153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495,049</a:t>
            </a:r>
            <a:endParaRPr lang="en-US" sz="1200" dirty="0">
              <a:solidFill>
                <a:schemeClr val="tx1"/>
              </a:solidFill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4113484" y="2890345"/>
            <a:ext cx="0" cy="40163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409759" y="2885430"/>
            <a:ext cx="134006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ecord of death only</a:t>
            </a:r>
          </a:p>
          <a:p>
            <a:r>
              <a:rPr lang="en-US" sz="800" dirty="0" smtClean="0"/>
              <a:t>N=4255</a:t>
            </a:r>
            <a:endParaRPr lang="en-US" sz="800" dirty="0"/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4125313" y="3070096"/>
            <a:ext cx="129627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ectangle 28"/>
          <p:cNvSpPr/>
          <p:nvPr/>
        </p:nvSpPr>
        <p:spPr>
          <a:xfrm>
            <a:off x="3524468" y="4092524"/>
            <a:ext cx="1178033" cy="3218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495,037</a:t>
            </a:r>
            <a:endParaRPr lang="en-US" sz="1200" dirty="0">
              <a:solidFill>
                <a:schemeClr val="tx1"/>
              </a:solidFill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4134069" y="3607296"/>
            <a:ext cx="0" cy="4852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409759" y="3494247"/>
            <a:ext cx="1340069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Negative person years from entry to exit </a:t>
            </a:r>
          </a:p>
          <a:p>
            <a:r>
              <a:rPr lang="en-US" sz="800" dirty="0" smtClean="0"/>
              <a:t>N=12</a:t>
            </a:r>
            <a:endParaRPr lang="en-US" sz="800" dirty="0"/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4125311" y="3807401"/>
            <a:ext cx="129627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3500380" y="4915328"/>
            <a:ext cx="1202121" cy="3135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</a:rPr>
              <a:t>N=470,000</a:t>
            </a:r>
            <a:endParaRPr lang="en-US" sz="1200" dirty="0">
              <a:solidFill>
                <a:schemeClr val="tx1"/>
              </a:solidFill>
            </a:endParaRPr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4134069" y="4414345"/>
            <a:ext cx="0" cy="4852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451365" y="4271977"/>
            <a:ext cx="1340069" cy="6771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issing data on cancer risk factors and/or race</a:t>
            </a:r>
          </a:p>
          <a:p>
            <a:r>
              <a:rPr lang="en-US" sz="800" dirty="0" smtClean="0"/>
              <a:t>N=50,242</a:t>
            </a:r>
            <a:endParaRPr lang="en-US" sz="800" dirty="0"/>
          </a:p>
        </p:txBody>
      </p:sp>
      <p:cxnSp>
        <p:nvCxnSpPr>
          <p:cNvPr id="43" name="Straight Arrow Connector 42"/>
          <p:cNvCxnSpPr/>
          <p:nvPr/>
        </p:nvCxnSpPr>
        <p:spPr>
          <a:xfrm>
            <a:off x="4155090" y="4610531"/>
            <a:ext cx="129627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4141075" y="5228897"/>
            <a:ext cx="0" cy="3354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3713656" y="5564392"/>
            <a:ext cx="8758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3713656" y="5564392"/>
            <a:ext cx="0" cy="3354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4589518" y="5576563"/>
            <a:ext cx="0" cy="3354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3380830" y="5899886"/>
            <a:ext cx="846083" cy="5062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</a:rPr>
              <a:t>African-Americans N=19,677</a:t>
            </a:r>
            <a:endParaRPr lang="en-US" sz="1000" dirty="0">
              <a:solidFill>
                <a:schemeClr val="tx1"/>
              </a:solidFill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4381063" y="5912058"/>
            <a:ext cx="851337" cy="5062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</a:rPr>
              <a:t>Whites</a:t>
            </a:r>
          </a:p>
          <a:p>
            <a:pPr algn="ctr"/>
            <a:r>
              <a:rPr lang="en-US" sz="1000" dirty="0" smtClean="0">
                <a:solidFill>
                  <a:schemeClr val="tx1"/>
                </a:solidFill>
              </a:rPr>
              <a:t>N=450,623</a:t>
            </a:r>
            <a:endParaRPr lang="en-US" sz="1000" dirty="0">
              <a:solidFill>
                <a:schemeClr val="tx1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134100" y="6187484"/>
            <a:ext cx="3009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Additional File </a:t>
            </a:r>
            <a:r>
              <a:rPr lang="en-US" sz="1200" dirty="0" smtClean="0"/>
              <a:t>1: Participant flowchart for NIH-AARP Diet and Health Study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70523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75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motomilayo Akinyemiju</dc:creator>
  <cp:lastModifiedBy>Taylor Wyatt</cp:lastModifiedBy>
  <cp:revision>8</cp:revision>
  <dcterms:created xsi:type="dcterms:W3CDTF">2016-11-02T14:22:34Z</dcterms:created>
  <dcterms:modified xsi:type="dcterms:W3CDTF">2017-01-05T16:05:36Z</dcterms:modified>
</cp:coreProperties>
</file>